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C15BAC9-1F23-4F2C-9B6E-9DC34F0CCDDB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5644221-7FC2-4150-B1CC-82EF0D7B47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D7002B7-87CD-4A67-82DB-047A7A77D1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76E9EAB-EED7-432A-A755-CA2F60E4D2A2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1C40AB2-31B6-41F5-82AD-B31C33438B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9BFE58D-D301-421D-A6D6-EDF9BEF0FD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8E86D62-0B0B-4F99-86CB-A83903D720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C2118C5-4D88-4813-8462-89E543B20F1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6480"/>
            <a:ext cx="6170400" cy="705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F4391B4-04C2-454F-B8BE-B6E939DB0CD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1ED6E1F-6642-4488-A5F1-B9E2344B04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DEAB17B-A894-4DAB-8A09-34C19D27B5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5BAA884-2462-4C02-9C0C-826D737B71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3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&lt;date/time&gt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2343240" y="8475840"/>
            <a:ext cx="217152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4915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89F96292-E827-4D83-8EF1-0FE6464CF270}" type="slidenum"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28600" y="8381880"/>
            <a:ext cx="4057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宋体"/>
              </a:rPr>
              <a:t>Additional File 1: Table S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533520" y="380880"/>
          <a:ext cx="4343400" cy="7040160"/>
        </p:xfrm>
        <a:graphic>
          <a:graphicData uri="http://schemas.openxmlformats.org/drawingml/2006/table">
            <a:tbl>
              <a:tblPr/>
              <a:tblGrid>
                <a:gridCol w="1492200"/>
                <a:gridCol w="2851200"/>
              </a:tblGrid>
              <a:tr h="335160">
                <a:tc>
                  <a:txBody>
                    <a:bodyPr lIns="39960" rIns="39960" tIns="0" bIns="0" anchor="b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RT-PCR Prime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960" rIns="39960" tIns="0" bIns="0" anchor="b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Sequenc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4800"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PRL-1/forwar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’-ATGGCTCGAATGAACCGCCC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36600"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PRL-1/rever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’-TTATTGAATGCAACAGTTGT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5160"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PRL-2/forwar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’-ATGAACCGTCCAGCCCCTGT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4800"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PRL-2/rever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’-CTACTGAACACAGCAATGCC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5160"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PRL-3/forwar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’-ATGGCTCGGATGAACCGCCCG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5160"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PRL-3/rever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’-CTACATAACGCAGCACCGGG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6600"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Integrin α2/forwar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’-TGTCCAGAAGACATCTCATGGC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4800"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Integrin α2/rever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’-GTGGTGAACCAACAATCACATC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5160"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Integrin β1/forwar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’-GGAATGCCTACTTCTGCACGATG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5160"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Integrin β1/rever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’-AAGTCCGAAGTAATCCTCCTCA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5160"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Paxillin/forwar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’-AGTCTCTTGGATGAACTGGAGA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4800"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Paxillin/rever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’-GATCCGATCTCCTCCTGGCA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4800"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c-fos/forwar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’-ACTACGAGGCGTCATCCTC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5160"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c-fos/rever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’-TGGGAAGCCCAGGTCATC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5160"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c-jun/forwar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’-CGAGTCGACAAGTAAGAGTG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5160"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c-jun/rever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’-GGTCGGCGTGGTGGTGATGT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6600"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Sp1/forwar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’-ACCAAGATCACTCCATGGAT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4800"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Sp1/rever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’-AGCGGCAGCCACAACATACT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5160"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GAPDH/forwar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’-CCCTTCATTGACCTCAACTA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4800"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GAPDH/rever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’-CCAAAGTTGTCATGGATGAC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07T01:30:27Z</dcterms:created>
  <dc:creator>mcbguok</dc:creator>
  <dc:description/>
  <dc:language>en-US</dc:language>
  <cp:lastModifiedBy>Liu Hao</cp:lastModifiedBy>
  <dcterms:modified xsi:type="dcterms:W3CDTF">2013-02-13T04:38:59Z</dcterms:modified>
  <cp:revision>157</cp:revision>
  <dc:subject/>
  <dc:title>Slide 1</dc:title>
</cp:coreProperties>
</file>